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wmf" ContentType="image/x-w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143" d="100"/>
          <a:sy n="143" d="100"/>
        </p:scale>
        <p:origin x="-112" y="-3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AppData\Local\Temp\Calculations.od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4404832093923"/>
          <c:y val="0.0639452454866621"/>
          <c:w val="0.631348522788785"/>
          <c:h val="0.836065644006405"/>
        </c:manualLayout>
      </c:layout>
      <c:scatterChart>
        <c:scatterStyle val="lineMarker"/>
        <c:varyColors val="0"/>
        <c:ser>
          <c:idx val="0"/>
          <c:order val="0"/>
          <c:tx>
            <c:strRef>
              <c:f>[Calculations.ods]Sheet1!$F$5</c:f>
              <c:strCache>
                <c:ptCount val="1"/>
                <c:pt idx="0">
                  <c:v>area</c:v>
                </c:pt>
              </c:strCache>
            </c:strRef>
          </c:tx>
          <c:spPr>
            <a:ln w="28800">
              <a:solidFill>
                <a:srgbClr val="004586"/>
              </a:solidFill>
            </a:ln>
          </c:spPr>
          <c:marker>
            <c:symbol val="square"/>
            <c:size val="7"/>
          </c:marker>
          <c:trendline>
            <c:spPr>
              <a:ln>
                <a:solidFill>
                  <a:srgbClr val="004586"/>
                </a:solidFill>
              </a:ln>
            </c:spPr>
            <c:trendlineType val="power"/>
            <c:dispRSqr val="1"/>
            <c:dispEq val="1"/>
            <c:trendlineLbl>
              <c:layout/>
              <c:numFmt formatCode="General" sourceLinked="0"/>
            </c:trendlineLbl>
          </c:trendline>
          <c:xVal>
            <c:numRef>
              <c:f>[Calculations.ods]Sheet1!$E$6:$E$9</c:f>
              <c:numCache>
                <c:formatCode>General</c:formatCode>
                <c:ptCount val="4"/>
                <c:pt idx="0">
                  <c:v>0.0</c:v>
                </c:pt>
                <c:pt idx="1">
                  <c:v>0.16</c:v>
                </c:pt>
                <c:pt idx="2">
                  <c:v>0.31</c:v>
                </c:pt>
                <c:pt idx="3">
                  <c:v>0.62</c:v>
                </c:pt>
              </c:numCache>
            </c:numRef>
          </c:xVal>
          <c:yVal>
            <c:numRef>
              <c:f>[Calculations.ods]Sheet1!$F$6:$F$9</c:f>
              <c:numCache>
                <c:formatCode>General</c:formatCode>
                <c:ptCount val="4"/>
                <c:pt idx="0">
                  <c:v>0.0</c:v>
                </c:pt>
                <c:pt idx="1">
                  <c:v>1.02256444E8</c:v>
                </c:pt>
                <c:pt idx="2">
                  <c:v>5.0265982E8</c:v>
                </c:pt>
                <c:pt idx="3">
                  <c:v>1.80185054E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05032552"/>
        <c:axId val="2122451736"/>
      </c:scatterChart>
      <c:valAx>
        <c:axId val="212245173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ln>
            <a:solidFill>
              <a:srgbClr val="B3B3B3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2105032552"/>
        <c:crossesAt val="0.0"/>
        <c:crossBetween val="midCat"/>
      </c:valAx>
      <c:valAx>
        <c:axId val="2105032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rgbClr val="B3B3B3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2122451736"/>
        <c:crossesAt val="0.0"/>
        <c:crossBetween val="midCat"/>
      </c:valAx>
      <c:spPr>
        <a:noFill/>
        <a:ln>
          <a:solidFill>
            <a:srgbClr val="B3B3B3"/>
          </a:solidFill>
          <a:prstDash val="solid"/>
        </a:ln>
      </c:spPr>
    </c:plotArea>
    <c:legend>
      <c:legendPos val="r"/>
      <c:layout/>
      <c:overlay val="0"/>
      <c:spPr>
        <a:noFill/>
        <a:ln>
          <a:noFill/>
        </a:ln>
      </c:spPr>
      <c:txPr>
        <a:bodyPr/>
        <a:lstStyle/>
        <a:p>
          <a:pPr>
            <a:defRPr sz="1000" b="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419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627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475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164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33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610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08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6139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541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596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223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8160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4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583674" y="113196"/>
            <a:ext cx="5674130" cy="3680328"/>
            <a:chOff x="5765275" y="442709"/>
            <a:chExt cx="6087999" cy="4899313"/>
          </a:xfrm>
        </p:grpSpPr>
        <p:pic>
          <p:nvPicPr>
            <p:cNvPr id="21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94174" y="855424"/>
              <a:ext cx="5943600" cy="1773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2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09674" y="2834142"/>
              <a:ext cx="5943600" cy="22653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3" name="TextBox 22"/>
            <p:cNvSpPr txBox="1"/>
            <p:nvPr/>
          </p:nvSpPr>
          <p:spPr>
            <a:xfrm>
              <a:off x="5765275" y="442709"/>
              <a:ext cx="290750" cy="4005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57"/>
            <p:cNvSpPr txBox="1">
              <a:spLocks noChangeArrowheads="1"/>
            </p:cNvSpPr>
            <p:nvPr/>
          </p:nvSpPr>
          <p:spPr bwMode="auto">
            <a:xfrm>
              <a:off x="9207674" y="1006356"/>
              <a:ext cx="1397000" cy="2232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ndard Azelaic acid</a:t>
              </a:r>
            </a:p>
          </p:txBody>
        </p:sp>
        <p:sp>
          <p:nvSpPr>
            <p:cNvPr id="25" name="TextBox 50"/>
            <p:cNvSpPr txBox="1">
              <a:spLocks noChangeArrowheads="1"/>
            </p:cNvSpPr>
            <p:nvPr/>
          </p:nvSpPr>
          <p:spPr bwMode="auto">
            <a:xfrm>
              <a:off x="9207674" y="1666264"/>
              <a:ext cx="892175" cy="2232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13</a:t>
              </a:r>
            </a:p>
          </p:txBody>
        </p:sp>
        <p:cxnSp>
          <p:nvCxnSpPr>
            <p:cNvPr id="26" name="Straight Arrow Connector 25"/>
            <p:cNvCxnSpPr/>
            <p:nvPr/>
          </p:nvCxnSpPr>
          <p:spPr>
            <a:xfrm flipH="1">
              <a:off x="9072948" y="1792381"/>
              <a:ext cx="128716" cy="15576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62"/>
            <p:cNvSpPr txBox="1">
              <a:spLocks noChangeArrowheads="1"/>
            </p:cNvSpPr>
            <p:nvPr/>
          </p:nvSpPr>
          <p:spPr bwMode="auto">
            <a:xfrm>
              <a:off x="8715225" y="2617749"/>
              <a:ext cx="1512888" cy="2232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in min 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 rot="16200000">
              <a:off x="5057136" y="1560108"/>
              <a:ext cx="1711558" cy="2756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Intensity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917676" y="820680"/>
              <a:ext cx="7187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-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6057958" y="928276"/>
              <a:ext cx="21833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800" dirty="0"/>
            </a:p>
          </p:txBody>
        </p:sp>
        <p:sp>
          <p:nvSpPr>
            <p:cNvPr id="31" name="Rectangle 30"/>
            <p:cNvSpPr/>
            <p:nvPr/>
          </p:nvSpPr>
          <p:spPr>
            <a:xfrm>
              <a:off x="6066196" y="1261884"/>
              <a:ext cx="21833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8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5910623" y="1632817"/>
              <a:ext cx="7187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-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32"/>
            <p:cNvSpPr/>
            <p:nvPr/>
          </p:nvSpPr>
          <p:spPr>
            <a:xfrm>
              <a:off x="6050905" y="1983403"/>
              <a:ext cx="21833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8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8957616" y="5126578"/>
              <a:ext cx="433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/z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50"/>
            <p:cNvSpPr txBox="1">
              <a:spLocks noChangeArrowheads="1"/>
            </p:cNvSpPr>
            <p:nvPr/>
          </p:nvSpPr>
          <p:spPr bwMode="auto">
            <a:xfrm>
              <a:off x="9242344" y="3943590"/>
              <a:ext cx="892175" cy="2232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13</a:t>
              </a:r>
            </a:p>
          </p:txBody>
        </p:sp>
        <p:cxnSp>
          <p:nvCxnSpPr>
            <p:cNvPr id="36" name="Straight Arrow Connector 35"/>
            <p:cNvCxnSpPr/>
            <p:nvPr/>
          </p:nvCxnSpPr>
          <p:spPr>
            <a:xfrm flipH="1">
              <a:off x="9107618" y="4069707"/>
              <a:ext cx="128716" cy="15576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57"/>
            <p:cNvSpPr txBox="1">
              <a:spLocks noChangeArrowheads="1"/>
            </p:cNvSpPr>
            <p:nvPr/>
          </p:nvSpPr>
          <p:spPr bwMode="auto">
            <a:xfrm>
              <a:off x="9289706" y="3056160"/>
              <a:ext cx="1397000" cy="2232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ndard Azelaic acid</a:t>
              </a:r>
            </a:p>
          </p:txBody>
        </p:sp>
      </p:grpSp>
      <p:graphicFrame>
        <p:nvGraphicFramePr>
          <p:cNvPr id="38" name="Chart 37"/>
          <p:cNvGraphicFramePr>
            <a:graphicFrameLocks/>
          </p:cNvGraphicFramePr>
          <p:nvPr>
            <p:extLst/>
          </p:nvPr>
        </p:nvGraphicFramePr>
        <p:xfrm>
          <a:off x="6376213" y="293999"/>
          <a:ext cx="4687204" cy="25480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1" name="Table 40"/>
          <p:cNvGraphicFramePr>
            <a:graphicFrameLocks noGrp="1"/>
          </p:cNvGraphicFramePr>
          <p:nvPr>
            <p:extLst/>
          </p:nvPr>
        </p:nvGraphicFramePr>
        <p:xfrm>
          <a:off x="6785287" y="2967705"/>
          <a:ext cx="3869055" cy="2557802"/>
        </p:xfrm>
        <a:graphic>
          <a:graphicData uri="http://schemas.openxmlformats.org/drawingml/2006/table">
            <a:tbl>
              <a:tblPr firstRow="1" firstCol="1" bandRow="1"/>
              <a:tblGrid>
                <a:gridCol w="1289685"/>
                <a:gridCol w="1289685"/>
                <a:gridCol w="1289685"/>
              </a:tblGrid>
              <a:tr h="77533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mple </a:t>
                      </a:r>
                      <a:r>
                        <a:rPr lang="en-US" sz="11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 µg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rea m/z 171 from 188.9 (parent ion)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lank </a:t>
                      </a:r>
                      <a:r>
                        <a:rPr lang="en-US" sz="1100" b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ubtracted Area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3067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lank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8,185,988.0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1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25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(0.16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7,372,816.0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2,256,444.0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76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(0.31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57,776,192.0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2,659,820.0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25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(0.62)</a:t>
                      </a: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,856,966,912.00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,801,850,540.0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76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(1.25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,400,860,544.00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,345,744,172.0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25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(2.5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,896,498,304.00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,841,381,932.0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25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T 13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,149,919,232.00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,094,802,860.00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566098" y="5737686"/>
            <a:ext cx="111518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Additional file 4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  <a:ea typeface="Times New Roman"/>
              </a:rPr>
              <a:t>: </a:t>
            </a:r>
            <a:r>
              <a:rPr lang="en-US" sz="1200" b="1" dirty="0" smtClean="0">
                <a:solidFill>
                  <a:srgbClr val="000000"/>
                </a:solidFill>
                <a:latin typeface="Times New Roman"/>
                <a:ea typeface="Times New Roman"/>
              </a:rPr>
              <a:t>Figure showing Quantification </a:t>
            </a:r>
            <a:r>
              <a:rPr lang="en-US" sz="1200" b="1" dirty="0">
                <a:solidFill>
                  <a:srgbClr val="000000"/>
                </a:solidFill>
                <a:latin typeface="Times New Roman"/>
                <a:ea typeface="Times New Roman"/>
              </a:rPr>
              <a:t>of azelaic acid by LC-MS</a:t>
            </a:r>
            <a:endParaRPr lang="en-US" sz="1200" dirty="0">
              <a:latin typeface="Times New Roman"/>
              <a:ea typeface="Times New Roman"/>
            </a:endParaRPr>
          </a:p>
          <a:p>
            <a:pPr algn="just"/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</a:rPr>
              <a:t>LC-MS profile of standard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Times New Roman"/>
              </a:rPr>
              <a:t>azelaic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</a:rPr>
              <a:t> acid and putative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Times New Roman"/>
              </a:rPr>
              <a:t>azelaic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</a:rPr>
              <a:t> acid collected at RT 13 from HPLC </a:t>
            </a:r>
            <a:r>
              <a:rPr lang="en-US" sz="1200" b="1" dirty="0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</a:rPr>
              <a:t>. Quantification of isolated and purified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Times New Roman"/>
              </a:rPr>
              <a:t>azelaic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</a:rPr>
              <a:t> acid by standard curve </a:t>
            </a:r>
            <a:r>
              <a:rPr lang="en-US" sz="1200" b="1" dirty="0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</a:rPr>
              <a:t>.  In 5 µl of RT 13 sample injected, there is 0.476µg of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Times New Roman"/>
              </a:rPr>
              <a:t>azelaic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Times New Roman"/>
              </a:rPr>
              <a:t> acid which can be translated to 19.992µg/L.</a:t>
            </a:r>
            <a:endParaRPr lang="en-US" sz="1200" dirty="0">
              <a:latin typeface="Times New Roman"/>
              <a:ea typeface="Times New Roman"/>
            </a:endParaRP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898335" y="79313"/>
            <a:ext cx="2597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 rot="16200000">
            <a:off x="242914" y="2460716"/>
            <a:ext cx="9059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undanc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6200000">
            <a:off x="5866626" y="1004730"/>
            <a:ext cx="10285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8106007" y="2756277"/>
            <a:ext cx="17572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 in </a:t>
            </a:r>
            <a:r>
              <a:rPr lang="en-US" sz="10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µg</a:t>
            </a:r>
            <a:endParaRPr lang="en-US" sz="1000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dirty="0" smtClean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305281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61</Words>
  <Application>Microsoft Macintosh PowerPoint</Application>
  <PresentationFormat>Custom</PresentationFormat>
  <Paragraphs>4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ICGEB ICGEB</cp:lastModifiedBy>
  <cp:revision>5</cp:revision>
  <dcterms:created xsi:type="dcterms:W3CDTF">2017-06-03T12:12:18Z</dcterms:created>
  <dcterms:modified xsi:type="dcterms:W3CDTF">2018-11-01T10:15:43Z</dcterms:modified>
</cp:coreProperties>
</file>